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83" r:id="rId2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0" d="100"/>
          <a:sy n="120" d="100"/>
        </p:scale>
        <p:origin x="2736" y="3210"/>
      </p:cViewPr>
      <p:guideLst>
        <p:guide orient="horz" pos="3840"/>
        <p:guide pos="5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B3AE4D-D585-474E-ADE9-C8A9A7091F18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CF7499-8023-45B5-BDB9-D34A36751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1312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67856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09483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41483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04512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12732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27687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9330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01020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3541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64953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39920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0354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4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039" t="515" r="30039" b="55414"/>
          <a:stretch/>
        </p:blipFill>
        <p:spPr>
          <a:xfrm>
            <a:off x="7167174" y="5624761"/>
            <a:ext cx="1820137" cy="1936924"/>
          </a:xfrm>
        </p:spPr>
      </p:pic>
      <p:cxnSp>
        <p:nvCxnSpPr>
          <p:cNvPr id="13" name="肘形连接符 12"/>
          <p:cNvCxnSpPr/>
          <p:nvPr/>
        </p:nvCxnSpPr>
        <p:spPr>
          <a:xfrm flipV="1">
            <a:off x="6817274" y="4410348"/>
            <a:ext cx="2342689" cy="167745"/>
          </a:xfrm>
          <a:prstGeom prst="bentConnector3">
            <a:avLst>
              <a:gd name="adj1" fmla="val 80409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8696850" y="4226389"/>
            <a:ext cx="580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TG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736170" y="4384235"/>
            <a:ext cx="11433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900" i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tLOX1 </a:t>
            </a:r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moter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631407" y="4657730"/>
            <a:ext cx="5760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605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6" name="直接连接符 25"/>
          <p:cNvCxnSpPr/>
          <p:nvPr/>
        </p:nvCxnSpPr>
        <p:spPr>
          <a:xfrm>
            <a:off x="6817271" y="4420980"/>
            <a:ext cx="0" cy="16774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矩形 26"/>
          <p:cNvSpPr/>
          <p:nvPr/>
        </p:nvSpPr>
        <p:spPr>
          <a:xfrm>
            <a:off x="7393335" y="4480731"/>
            <a:ext cx="18000" cy="180000"/>
          </a:xfrm>
          <a:prstGeom prst="rect">
            <a:avLst/>
          </a:prstGeom>
          <a:solidFill>
            <a:schemeClr val="tx1"/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466"/>
            <a:endParaRPr lang="zh-CN" altLang="en-US" sz="900">
              <a:solidFill>
                <a:prstClr val="white"/>
              </a:solidFill>
              <a:latin typeface="Calibri"/>
              <a:ea typeface="宋体" panose="02010600030101010101" pitchFamily="2" charset="-122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249319" y="4162578"/>
            <a:ext cx="4144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3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7204783" y="4650098"/>
            <a:ext cx="4675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473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743152" y="3883853"/>
            <a:ext cx="1531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altLang="en-US" sz="14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33" name="直接连接符 32"/>
          <p:cNvCxnSpPr/>
          <p:nvPr/>
        </p:nvCxnSpPr>
        <p:spPr>
          <a:xfrm>
            <a:off x="7279725" y="7534902"/>
            <a:ext cx="14221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7307085" y="7542853"/>
            <a:ext cx="14219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3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787905" y="4967085"/>
            <a:ext cx="720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endParaRPr lang="zh-CN" altLang="en-US" sz="14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315010" y="5172944"/>
            <a:ext cx="13475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-</a:t>
            </a:r>
          </a:p>
          <a:p>
            <a:pPr defTabSz="914466"/>
            <a:r>
              <a:rPr lang="en-US" altLang="zh-CN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-</a:t>
            </a:r>
          </a:p>
          <a:p>
            <a:pPr defTabSz="914466"/>
            <a:r>
              <a:rPr lang="en-US" altLang="zh-CN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-</a:t>
            </a:r>
            <a:endParaRPr lang="zh-CN" altLang="en-US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544005" y="5184819"/>
            <a:ext cx="270385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66"/>
            <a:r>
              <a:rPr lang="en-US" altLang="zh-CN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+</a:t>
            </a:r>
          </a:p>
          <a:p>
            <a:pPr algn="ctr" defTabSz="914466"/>
            <a:r>
              <a:rPr lang="en-US" altLang="zh-CN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-</a:t>
            </a:r>
          </a:p>
          <a:p>
            <a:pPr algn="ctr" defTabSz="914466"/>
            <a:r>
              <a:rPr lang="en-US" altLang="zh-CN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-</a:t>
            </a:r>
            <a:endParaRPr lang="zh-CN" altLang="en-US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901433" y="5176136"/>
            <a:ext cx="13475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66"/>
            <a:r>
              <a:rPr lang="en-US" altLang="zh-CN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-</a:t>
            </a:r>
          </a:p>
          <a:p>
            <a:pPr algn="ctr" defTabSz="914466"/>
            <a:endParaRPr lang="en-US" altLang="zh-CN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  <a:p>
            <a:pPr algn="ctr" defTabSz="914466"/>
            <a:r>
              <a:rPr lang="en-US" altLang="zh-CN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-</a:t>
            </a:r>
            <a:endParaRPr lang="zh-CN" altLang="en-US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994436" y="5168881"/>
            <a:ext cx="47320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914466"/>
            <a:r>
              <a:rPr lang="en-US" altLang="zh-CN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-</a:t>
            </a:r>
          </a:p>
          <a:p>
            <a:pPr algn="ctr" defTabSz="914466"/>
            <a:r>
              <a:rPr lang="en-US" altLang="zh-CN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+</a:t>
            </a:r>
          </a:p>
          <a:p>
            <a:pPr algn="ctr"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00×</a:t>
            </a:r>
            <a:endParaRPr lang="en-US" altLang="zh-CN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  <a:p>
            <a:pPr algn="ctr" defTabSz="914466"/>
            <a:endParaRPr lang="zh-CN" altLang="en-US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330726" y="5158478"/>
            <a:ext cx="47320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914466"/>
            <a:r>
              <a:rPr lang="en-US" altLang="zh-CN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-</a:t>
            </a:r>
          </a:p>
          <a:p>
            <a:pPr algn="ctr" defTabSz="914466"/>
            <a:r>
              <a:rPr lang="en-US" altLang="zh-CN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rPr>
              <a:t>+</a:t>
            </a:r>
          </a:p>
          <a:p>
            <a:pPr algn="ctr"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00×</a:t>
            </a:r>
            <a:endParaRPr lang="en-US" altLang="zh-CN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  <a:p>
            <a:pPr algn="ctr" defTabSz="914466"/>
            <a:endParaRPr lang="zh-CN" altLang="en-US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643889" y="5176136"/>
            <a:ext cx="172819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BP</a:t>
            </a:r>
          </a:p>
          <a:p>
            <a:pPr algn="r"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BP-TaWRKY42-B</a:t>
            </a:r>
          </a:p>
          <a:p>
            <a:pPr algn="r"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mpetitor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7587148" y="4911709"/>
            <a:ext cx="12167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be-labeled 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/>
          <p:cNvCxnSpPr/>
          <p:nvPr/>
        </p:nvCxnSpPr>
        <p:spPr>
          <a:xfrm>
            <a:off x="7398817" y="5184817"/>
            <a:ext cx="11931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6190773" y="5783308"/>
            <a:ext cx="84557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tein </a:t>
            </a:r>
          </a:p>
          <a:p>
            <a:pPr algn="r"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be </a:t>
            </a:r>
          </a:p>
          <a:p>
            <a:pPr algn="r" defTabSz="914466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mplex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40" name="直接箭头连接符 39"/>
          <p:cNvCxnSpPr/>
          <p:nvPr/>
        </p:nvCxnSpPr>
        <p:spPr>
          <a:xfrm>
            <a:off x="6999305" y="603113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7842229" y="5305656"/>
            <a:ext cx="2520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endParaRPr lang="zh-CN" altLang="en-US" sz="900" dirty="0">
              <a:solidFill>
                <a:prstClr val="black"/>
              </a:solidFill>
              <a:latin typeface="Calibri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790910" y="3006313"/>
            <a:ext cx="2304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1400" kern="100" dirty="0">
                <a:solidFill>
                  <a:prstClr val="black"/>
                </a:solidFill>
                <a:latin typeface="Times New Roman"/>
                <a:ea typeface="宋体" panose="02010600030101010101" pitchFamily="2" charset="-122"/>
              </a:rPr>
              <a:t>Additional file 6: Fig. S6</a:t>
            </a:r>
            <a:endParaRPr lang="zh-CN" altLang="en-US" sz="14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7825021" y="5788622"/>
            <a:ext cx="3811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7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.0</a:t>
            </a:r>
            <a:endParaRPr lang="zh-CN" altLang="en-US" sz="7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083751" y="5781527"/>
            <a:ext cx="3811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7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.21</a:t>
            </a:r>
            <a:endParaRPr lang="zh-CN" altLang="en-US" sz="7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8374380" y="5783308"/>
            <a:ext cx="3811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66"/>
            <a:r>
              <a:rPr lang="en-US" altLang="zh-CN" sz="7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.26</a:t>
            </a:r>
            <a:endParaRPr lang="zh-CN" altLang="en-US" sz="7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xmlns="" id="{1A68110C-6E9E-496E-9385-CD9C9FCDA9D4}"/>
              </a:ext>
            </a:extLst>
          </p:cNvPr>
          <p:cNvSpPr/>
          <p:nvPr/>
        </p:nvSpPr>
        <p:spPr>
          <a:xfrm>
            <a:off x="4762500" y="8250180"/>
            <a:ext cx="6652260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05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le 6: Fig. S6 TaWRKY42-B can’t directly bind to promotor of </a:t>
            </a:r>
            <a:r>
              <a:rPr lang="en-US" altLang="zh-CN" sz="1050" b="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tLOX1</a:t>
            </a:r>
            <a:r>
              <a:rPr lang="en-US" altLang="zh-CN" sz="105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05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Diagram of probes against </a:t>
            </a:r>
            <a:r>
              <a:rPr lang="en-US" altLang="zh-CN" sz="105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tLOX1 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moter region for EMSA. (b) The interaction between TaWRKY42-B and</a:t>
            </a:r>
            <a:r>
              <a:rPr lang="en-US" altLang="zh-CN" sz="105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moter region of </a:t>
            </a:r>
            <a:r>
              <a:rPr lang="en-US" altLang="zh-CN" sz="105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tLOX1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was analyzed by EMSA. TaWRKY42-B-MBP fusion protein mixed with labeled probes, and 100</a:t>
            </a:r>
            <a:r>
              <a:rPr lang="zh-CN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zh-CN" altLang="zh-CN" sz="105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 200</a:t>
            </a:r>
            <a:r>
              <a:rPr lang="zh-CN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zh-CN" altLang="zh-CN" sz="105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labeled probes served as competitors. The presence (+) or absence (-) represented specific probes existence or not. Numbers above the top of the bands indicate the relative binding strength of TaWRKY42-B-MBP fusion protein and labeled probes after normalization to control group.</a:t>
            </a:r>
            <a:endParaRPr lang="zh-CN" altLang="zh-CN" sz="105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989712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149</Words>
  <Application>Microsoft Office PowerPoint</Application>
  <PresentationFormat>自定义</PresentationFormat>
  <Paragraphs>3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2_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耕</dc:creator>
  <cp:lastModifiedBy>zhaomingming</cp:lastModifiedBy>
  <cp:revision>14</cp:revision>
  <dcterms:created xsi:type="dcterms:W3CDTF">2019-11-25T09:49:18Z</dcterms:created>
  <dcterms:modified xsi:type="dcterms:W3CDTF">2020-09-01T12:56:35Z</dcterms:modified>
</cp:coreProperties>
</file>